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6" r:id="rId2"/>
  </p:sldIdLst>
  <p:sldSz cx="13536613" cy="101520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98" userDrawn="1">
          <p15:clr>
            <a:srgbClr val="A4A3A4"/>
          </p15:clr>
        </p15:guide>
        <p15:guide id="2" pos="42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69" autoAdjust="0"/>
    <p:restoredTop sz="94660"/>
  </p:normalViewPr>
  <p:slideViewPr>
    <p:cSldViewPr snapToGrid="0" showGuides="1">
      <p:cViewPr varScale="1">
        <p:scale>
          <a:sx n="59" d="100"/>
          <a:sy n="59" d="100"/>
        </p:scale>
        <p:origin x="996" y="66"/>
      </p:cViewPr>
      <p:guideLst>
        <p:guide orient="horz" pos="3198"/>
        <p:guide pos="42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15246" y="1661461"/>
            <a:ext cx="11506121" cy="3534422"/>
          </a:xfrm>
        </p:spPr>
        <p:txBody>
          <a:bodyPr anchor="b"/>
          <a:lstStyle>
            <a:lvl1pPr algn="ctr">
              <a:defRPr sz="888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92077" y="5332184"/>
            <a:ext cx="10152460" cy="2451064"/>
          </a:xfrm>
        </p:spPr>
        <p:txBody>
          <a:bodyPr/>
          <a:lstStyle>
            <a:lvl1pPr marL="0" indent="0" algn="ctr">
              <a:buNone/>
              <a:defRPr sz="3553"/>
            </a:lvl1pPr>
            <a:lvl2pPr marL="676793" indent="0" algn="ctr">
              <a:buNone/>
              <a:defRPr sz="2961"/>
            </a:lvl2pPr>
            <a:lvl3pPr marL="1353586" indent="0" algn="ctr">
              <a:buNone/>
              <a:defRPr sz="2665"/>
            </a:lvl3pPr>
            <a:lvl4pPr marL="2030379" indent="0" algn="ctr">
              <a:buNone/>
              <a:defRPr sz="2368"/>
            </a:lvl4pPr>
            <a:lvl5pPr marL="2707173" indent="0" algn="ctr">
              <a:buNone/>
              <a:defRPr sz="2368"/>
            </a:lvl5pPr>
            <a:lvl6pPr marL="3383966" indent="0" algn="ctr">
              <a:buNone/>
              <a:defRPr sz="2368"/>
            </a:lvl6pPr>
            <a:lvl7pPr marL="4060759" indent="0" algn="ctr">
              <a:buNone/>
              <a:defRPr sz="2368"/>
            </a:lvl7pPr>
            <a:lvl8pPr marL="4737552" indent="0" algn="ctr">
              <a:buNone/>
              <a:defRPr sz="2368"/>
            </a:lvl8pPr>
            <a:lvl9pPr marL="5414345" indent="0" algn="ctr">
              <a:buNone/>
              <a:defRPr sz="2368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76E4-C5C2-4796-A869-879432AA7912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52284-1CF1-41FC-AAF3-6CE3DC0571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874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76E4-C5C2-4796-A869-879432AA7912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52284-1CF1-41FC-AAF3-6CE3DC0571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87176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687140" y="540503"/>
            <a:ext cx="2918832" cy="860340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30643" y="540503"/>
            <a:ext cx="8587289" cy="8603404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76E4-C5C2-4796-A869-879432AA7912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52284-1CF1-41FC-AAF3-6CE3DC0571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6542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76E4-C5C2-4796-A869-879432AA7912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52284-1CF1-41FC-AAF3-6CE3DC0571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6221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23592" y="2530969"/>
            <a:ext cx="11675329" cy="4222975"/>
          </a:xfrm>
        </p:spPr>
        <p:txBody>
          <a:bodyPr anchor="b"/>
          <a:lstStyle>
            <a:lvl1pPr>
              <a:defRPr sz="888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23592" y="6793895"/>
            <a:ext cx="11675329" cy="2220763"/>
          </a:xfrm>
        </p:spPr>
        <p:txBody>
          <a:bodyPr/>
          <a:lstStyle>
            <a:lvl1pPr marL="0" indent="0">
              <a:buNone/>
              <a:defRPr sz="3553">
                <a:solidFill>
                  <a:schemeClr val="tx1"/>
                </a:solidFill>
              </a:defRPr>
            </a:lvl1pPr>
            <a:lvl2pPr marL="676793" indent="0">
              <a:buNone/>
              <a:defRPr sz="2961">
                <a:solidFill>
                  <a:schemeClr val="tx1">
                    <a:tint val="75000"/>
                  </a:schemeClr>
                </a:solidFill>
              </a:defRPr>
            </a:lvl2pPr>
            <a:lvl3pPr marL="1353586" indent="0">
              <a:buNone/>
              <a:defRPr sz="2665">
                <a:solidFill>
                  <a:schemeClr val="tx1">
                    <a:tint val="75000"/>
                  </a:schemeClr>
                </a:solidFill>
              </a:defRPr>
            </a:lvl3pPr>
            <a:lvl4pPr marL="2030379" indent="0">
              <a:buNone/>
              <a:defRPr sz="2368">
                <a:solidFill>
                  <a:schemeClr val="tx1">
                    <a:tint val="75000"/>
                  </a:schemeClr>
                </a:solidFill>
              </a:defRPr>
            </a:lvl4pPr>
            <a:lvl5pPr marL="2707173" indent="0">
              <a:buNone/>
              <a:defRPr sz="2368">
                <a:solidFill>
                  <a:schemeClr val="tx1">
                    <a:tint val="75000"/>
                  </a:schemeClr>
                </a:solidFill>
              </a:defRPr>
            </a:lvl5pPr>
            <a:lvl6pPr marL="3383966" indent="0">
              <a:buNone/>
              <a:defRPr sz="2368">
                <a:solidFill>
                  <a:schemeClr val="tx1">
                    <a:tint val="75000"/>
                  </a:schemeClr>
                </a:solidFill>
              </a:defRPr>
            </a:lvl6pPr>
            <a:lvl7pPr marL="4060759" indent="0">
              <a:buNone/>
              <a:defRPr sz="2368">
                <a:solidFill>
                  <a:schemeClr val="tx1">
                    <a:tint val="75000"/>
                  </a:schemeClr>
                </a:solidFill>
              </a:defRPr>
            </a:lvl7pPr>
            <a:lvl8pPr marL="4737552" indent="0">
              <a:buNone/>
              <a:defRPr sz="2368">
                <a:solidFill>
                  <a:schemeClr val="tx1">
                    <a:tint val="75000"/>
                  </a:schemeClr>
                </a:solidFill>
              </a:defRPr>
            </a:lvl8pPr>
            <a:lvl9pPr marL="5414345" indent="0">
              <a:buNone/>
              <a:defRPr sz="23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76E4-C5C2-4796-A869-879432AA7912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52284-1CF1-41FC-AAF3-6CE3DC0571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8668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30642" y="2702517"/>
            <a:ext cx="5753061" cy="644139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52910" y="2702517"/>
            <a:ext cx="5753061" cy="644139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76E4-C5C2-4796-A869-879432AA7912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52284-1CF1-41FC-AAF3-6CE3DC0571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2873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2405" y="540506"/>
            <a:ext cx="11675329" cy="19622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2407" y="2488666"/>
            <a:ext cx="5726621" cy="1219657"/>
          </a:xfrm>
        </p:spPr>
        <p:txBody>
          <a:bodyPr anchor="b"/>
          <a:lstStyle>
            <a:lvl1pPr marL="0" indent="0">
              <a:buNone/>
              <a:defRPr sz="3553" b="1"/>
            </a:lvl1pPr>
            <a:lvl2pPr marL="676793" indent="0">
              <a:buNone/>
              <a:defRPr sz="2961" b="1"/>
            </a:lvl2pPr>
            <a:lvl3pPr marL="1353586" indent="0">
              <a:buNone/>
              <a:defRPr sz="2665" b="1"/>
            </a:lvl3pPr>
            <a:lvl4pPr marL="2030379" indent="0">
              <a:buNone/>
              <a:defRPr sz="2368" b="1"/>
            </a:lvl4pPr>
            <a:lvl5pPr marL="2707173" indent="0">
              <a:buNone/>
              <a:defRPr sz="2368" b="1"/>
            </a:lvl5pPr>
            <a:lvl6pPr marL="3383966" indent="0">
              <a:buNone/>
              <a:defRPr sz="2368" b="1"/>
            </a:lvl6pPr>
            <a:lvl7pPr marL="4060759" indent="0">
              <a:buNone/>
              <a:defRPr sz="2368" b="1"/>
            </a:lvl7pPr>
            <a:lvl8pPr marL="4737552" indent="0">
              <a:buNone/>
              <a:defRPr sz="2368" b="1"/>
            </a:lvl8pPr>
            <a:lvl9pPr marL="5414345" indent="0">
              <a:buNone/>
              <a:defRPr sz="236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32407" y="3708323"/>
            <a:ext cx="5726621" cy="5454385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852911" y="2488666"/>
            <a:ext cx="5754824" cy="1219657"/>
          </a:xfrm>
        </p:spPr>
        <p:txBody>
          <a:bodyPr anchor="b"/>
          <a:lstStyle>
            <a:lvl1pPr marL="0" indent="0">
              <a:buNone/>
              <a:defRPr sz="3553" b="1"/>
            </a:lvl1pPr>
            <a:lvl2pPr marL="676793" indent="0">
              <a:buNone/>
              <a:defRPr sz="2961" b="1"/>
            </a:lvl2pPr>
            <a:lvl3pPr marL="1353586" indent="0">
              <a:buNone/>
              <a:defRPr sz="2665" b="1"/>
            </a:lvl3pPr>
            <a:lvl4pPr marL="2030379" indent="0">
              <a:buNone/>
              <a:defRPr sz="2368" b="1"/>
            </a:lvl4pPr>
            <a:lvl5pPr marL="2707173" indent="0">
              <a:buNone/>
              <a:defRPr sz="2368" b="1"/>
            </a:lvl5pPr>
            <a:lvl6pPr marL="3383966" indent="0">
              <a:buNone/>
              <a:defRPr sz="2368" b="1"/>
            </a:lvl6pPr>
            <a:lvl7pPr marL="4060759" indent="0">
              <a:buNone/>
              <a:defRPr sz="2368" b="1"/>
            </a:lvl7pPr>
            <a:lvl8pPr marL="4737552" indent="0">
              <a:buNone/>
              <a:defRPr sz="2368" b="1"/>
            </a:lvl8pPr>
            <a:lvl9pPr marL="5414345" indent="0">
              <a:buNone/>
              <a:defRPr sz="236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852911" y="3708323"/>
            <a:ext cx="5754824" cy="5454385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76E4-C5C2-4796-A869-879432AA7912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52284-1CF1-41FC-AAF3-6CE3DC0571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418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76E4-C5C2-4796-A869-879432AA7912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52284-1CF1-41FC-AAF3-6CE3DC0571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7424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76E4-C5C2-4796-A869-879432AA7912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52284-1CF1-41FC-AAF3-6CE3DC0571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51558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2405" y="676804"/>
            <a:ext cx="4365910" cy="2368815"/>
          </a:xfrm>
        </p:spPr>
        <p:txBody>
          <a:bodyPr anchor="b"/>
          <a:lstStyle>
            <a:lvl1pPr>
              <a:defRPr sz="473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754824" y="1461711"/>
            <a:ext cx="6852910" cy="7214545"/>
          </a:xfrm>
        </p:spPr>
        <p:txBody>
          <a:bodyPr/>
          <a:lstStyle>
            <a:lvl1pPr>
              <a:defRPr sz="4737"/>
            </a:lvl1pPr>
            <a:lvl2pPr>
              <a:defRPr sz="4145"/>
            </a:lvl2pPr>
            <a:lvl3pPr>
              <a:defRPr sz="3553"/>
            </a:lvl3pPr>
            <a:lvl4pPr>
              <a:defRPr sz="2961"/>
            </a:lvl4pPr>
            <a:lvl5pPr>
              <a:defRPr sz="2961"/>
            </a:lvl5pPr>
            <a:lvl6pPr>
              <a:defRPr sz="2961"/>
            </a:lvl6pPr>
            <a:lvl7pPr>
              <a:defRPr sz="2961"/>
            </a:lvl7pPr>
            <a:lvl8pPr>
              <a:defRPr sz="2961"/>
            </a:lvl8pPr>
            <a:lvl9pPr>
              <a:defRPr sz="2961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32405" y="3045619"/>
            <a:ext cx="4365910" cy="5642386"/>
          </a:xfrm>
        </p:spPr>
        <p:txBody>
          <a:bodyPr/>
          <a:lstStyle>
            <a:lvl1pPr marL="0" indent="0">
              <a:buNone/>
              <a:defRPr sz="2368"/>
            </a:lvl1pPr>
            <a:lvl2pPr marL="676793" indent="0">
              <a:buNone/>
              <a:defRPr sz="2072"/>
            </a:lvl2pPr>
            <a:lvl3pPr marL="1353586" indent="0">
              <a:buNone/>
              <a:defRPr sz="1776"/>
            </a:lvl3pPr>
            <a:lvl4pPr marL="2030379" indent="0">
              <a:buNone/>
              <a:defRPr sz="1480"/>
            </a:lvl4pPr>
            <a:lvl5pPr marL="2707173" indent="0">
              <a:buNone/>
              <a:defRPr sz="1480"/>
            </a:lvl5pPr>
            <a:lvl6pPr marL="3383966" indent="0">
              <a:buNone/>
              <a:defRPr sz="1480"/>
            </a:lvl6pPr>
            <a:lvl7pPr marL="4060759" indent="0">
              <a:buNone/>
              <a:defRPr sz="1480"/>
            </a:lvl7pPr>
            <a:lvl8pPr marL="4737552" indent="0">
              <a:buNone/>
              <a:defRPr sz="1480"/>
            </a:lvl8pPr>
            <a:lvl9pPr marL="5414345" indent="0">
              <a:buNone/>
              <a:defRPr sz="148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76E4-C5C2-4796-A869-879432AA7912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52284-1CF1-41FC-AAF3-6CE3DC0571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4956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2405" y="676804"/>
            <a:ext cx="4365910" cy="2368815"/>
          </a:xfrm>
        </p:spPr>
        <p:txBody>
          <a:bodyPr anchor="b"/>
          <a:lstStyle>
            <a:lvl1pPr>
              <a:defRPr sz="473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754824" y="1461711"/>
            <a:ext cx="6852910" cy="7214545"/>
          </a:xfrm>
        </p:spPr>
        <p:txBody>
          <a:bodyPr anchor="t"/>
          <a:lstStyle>
            <a:lvl1pPr marL="0" indent="0">
              <a:buNone/>
              <a:defRPr sz="4737"/>
            </a:lvl1pPr>
            <a:lvl2pPr marL="676793" indent="0">
              <a:buNone/>
              <a:defRPr sz="4145"/>
            </a:lvl2pPr>
            <a:lvl3pPr marL="1353586" indent="0">
              <a:buNone/>
              <a:defRPr sz="3553"/>
            </a:lvl3pPr>
            <a:lvl4pPr marL="2030379" indent="0">
              <a:buNone/>
              <a:defRPr sz="2961"/>
            </a:lvl4pPr>
            <a:lvl5pPr marL="2707173" indent="0">
              <a:buNone/>
              <a:defRPr sz="2961"/>
            </a:lvl5pPr>
            <a:lvl6pPr marL="3383966" indent="0">
              <a:buNone/>
              <a:defRPr sz="2961"/>
            </a:lvl6pPr>
            <a:lvl7pPr marL="4060759" indent="0">
              <a:buNone/>
              <a:defRPr sz="2961"/>
            </a:lvl7pPr>
            <a:lvl8pPr marL="4737552" indent="0">
              <a:buNone/>
              <a:defRPr sz="2961"/>
            </a:lvl8pPr>
            <a:lvl9pPr marL="5414345" indent="0">
              <a:buNone/>
              <a:defRPr sz="2961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32405" y="3045619"/>
            <a:ext cx="4365910" cy="5642386"/>
          </a:xfrm>
        </p:spPr>
        <p:txBody>
          <a:bodyPr/>
          <a:lstStyle>
            <a:lvl1pPr marL="0" indent="0">
              <a:buNone/>
              <a:defRPr sz="2368"/>
            </a:lvl1pPr>
            <a:lvl2pPr marL="676793" indent="0">
              <a:buNone/>
              <a:defRPr sz="2072"/>
            </a:lvl2pPr>
            <a:lvl3pPr marL="1353586" indent="0">
              <a:buNone/>
              <a:defRPr sz="1776"/>
            </a:lvl3pPr>
            <a:lvl4pPr marL="2030379" indent="0">
              <a:buNone/>
              <a:defRPr sz="1480"/>
            </a:lvl4pPr>
            <a:lvl5pPr marL="2707173" indent="0">
              <a:buNone/>
              <a:defRPr sz="1480"/>
            </a:lvl5pPr>
            <a:lvl6pPr marL="3383966" indent="0">
              <a:buNone/>
              <a:defRPr sz="1480"/>
            </a:lvl6pPr>
            <a:lvl7pPr marL="4060759" indent="0">
              <a:buNone/>
              <a:defRPr sz="1480"/>
            </a:lvl7pPr>
            <a:lvl8pPr marL="4737552" indent="0">
              <a:buNone/>
              <a:defRPr sz="1480"/>
            </a:lvl8pPr>
            <a:lvl9pPr marL="5414345" indent="0">
              <a:buNone/>
              <a:defRPr sz="148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76E4-C5C2-4796-A869-879432AA7912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52284-1CF1-41FC-AAF3-6CE3DC0571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1007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30642" y="540506"/>
            <a:ext cx="11675329" cy="19622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0642" y="2702517"/>
            <a:ext cx="11675329" cy="64413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30642" y="9409461"/>
            <a:ext cx="3045738" cy="5405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2D76E4-C5C2-4796-A869-879432AA7912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484003" y="9409461"/>
            <a:ext cx="4568607" cy="5405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560233" y="9409461"/>
            <a:ext cx="3045738" cy="5405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352284-1CF1-41FC-AAF3-6CE3DC0571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2617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1353586" rtl="0" eaLnBrk="1" latinLnBrk="0" hangingPunct="1">
        <a:lnSpc>
          <a:spcPct val="90000"/>
        </a:lnSpc>
        <a:spcBef>
          <a:spcPct val="0"/>
        </a:spcBef>
        <a:buNone/>
        <a:defRPr sz="651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8397" indent="-338397" algn="l" defTabSz="1353586" rtl="0" eaLnBrk="1" latinLnBrk="0" hangingPunct="1">
        <a:lnSpc>
          <a:spcPct val="90000"/>
        </a:lnSpc>
        <a:spcBef>
          <a:spcPts val="1480"/>
        </a:spcBef>
        <a:buFont typeface="Arial" panose="020B0604020202020204" pitchFamily="34" charset="0"/>
        <a:buChar char="•"/>
        <a:defRPr sz="4145" kern="1200">
          <a:solidFill>
            <a:schemeClr val="tx1"/>
          </a:solidFill>
          <a:latin typeface="+mn-lt"/>
          <a:ea typeface="+mn-ea"/>
          <a:cs typeface="+mn-cs"/>
        </a:defRPr>
      </a:lvl1pPr>
      <a:lvl2pPr marL="1015190" indent="-338397" algn="l" defTabSz="1353586" rtl="0" eaLnBrk="1" latinLnBrk="0" hangingPunct="1">
        <a:lnSpc>
          <a:spcPct val="90000"/>
        </a:lnSpc>
        <a:spcBef>
          <a:spcPts val="740"/>
        </a:spcBef>
        <a:buFont typeface="Arial" panose="020B0604020202020204" pitchFamily="34" charset="0"/>
        <a:buChar char="•"/>
        <a:defRPr sz="3553" kern="1200">
          <a:solidFill>
            <a:schemeClr val="tx1"/>
          </a:solidFill>
          <a:latin typeface="+mn-lt"/>
          <a:ea typeface="+mn-ea"/>
          <a:cs typeface="+mn-cs"/>
        </a:defRPr>
      </a:lvl2pPr>
      <a:lvl3pPr marL="1691983" indent="-338397" algn="l" defTabSz="1353586" rtl="0" eaLnBrk="1" latinLnBrk="0" hangingPunct="1">
        <a:lnSpc>
          <a:spcPct val="90000"/>
        </a:lnSpc>
        <a:spcBef>
          <a:spcPts val="740"/>
        </a:spcBef>
        <a:buFont typeface="Arial" panose="020B0604020202020204" pitchFamily="34" charset="0"/>
        <a:buChar char="•"/>
        <a:defRPr sz="2961" kern="1200">
          <a:solidFill>
            <a:schemeClr val="tx1"/>
          </a:solidFill>
          <a:latin typeface="+mn-lt"/>
          <a:ea typeface="+mn-ea"/>
          <a:cs typeface="+mn-cs"/>
        </a:defRPr>
      </a:lvl3pPr>
      <a:lvl4pPr marL="2368776" indent="-338397" algn="l" defTabSz="1353586" rtl="0" eaLnBrk="1" latinLnBrk="0" hangingPunct="1">
        <a:lnSpc>
          <a:spcPct val="90000"/>
        </a:lnSpc>
        <a:spcBef>
          <a:spcPts val="740"/>
        </a:spcBef>
        <a:buFont typeface="Arial" panose="020B0604020202020204" pitchFamily="34" charset="0"/>
        <a:buChar char="•"/>
        <a:defRPr sz="2665" kern="1200">
          <a:solidFill>
            <a:schemeClr val="tx1"/>
          </a:solidFill>
          <a:latin typeface="+mn-lt"/>
          <a:ea typeface="+mn-ea"/>
          <a:cs typeface="+mn-cs"/>
        </a:defRPr>
      </a:lvl4pPr>
      <a:lvl5pPr marL="3045569" indent="-338397" algn="l" defTabSz="1353586" rtl="0" eaLnBrk="1" latinLnBrk="0" hangingPunct="1">
        <a:lnSpc>
          <a:spcPct val="90000"/>
        </a:lnSpc>
        <a:spcBef>
          <a:spcPts val="740"/>
        </a:spcBef>
        <a:buFont typeface="Arial" panose="020B0604020202020204" pitchFamily="34" charset="0"/>
        <a:buChar char="•"/>
        <a:defRPr sz="2665" kern="1200">
          <a:solidFill>
            <a:schemeClr val="tx1"/>
          </a:solidFill>
          <a:latin typeface="+mn-lt"/>
          <a:ea typeface="+mn-ea"/>
          <a:cs typeface="+mn-cs"/>
        </a:defRPr>
      </a:lvl5pPr>
      <a:lvl6pPr marL="3722362" indent="-338397" algn="l" defTabSz="1353586" rtl="0" eaLnBrk="1" latinLnBrk="0" hangingPunct="1">
        <a:lnSpc>
          <a:spcPct val="90000"/>
        </a:lnSpc>
        <a:spcBef>
          <a:spcPts val="740"/>
        </a:spcBef>
        <a:buFont typeface="Arial" panose="020B0604020202020204" pitchFamily="34" charset="0"/>
        <a:buChar char="•"/>
        <a:defRPr sz="2665" kern="1200">
          <a:solidFill>
            <a:schemeClr val="tx1"/>
          </a:solidFill>
          <a:latin typeface="+mn-lt"/>
          <a:ea typeface="+mn-ea"/>
          <a:cs typeface="+mn-cs"/>
        </a:defRPr>
      </a:lvl6pPr>
      <a:lvl7pPr marL="4399156" indent="-338397" algn="l" defTabSz="1353586" rtl="0" eaLnBrk="1" latinLnBrk="0" hangingPunct="1">
        <a:lnSpc>
          <a:spcPct val="90000"/>
        </a:lnSpc>
        <a:spcBef>
          <a:spcPts val="740"/>
        </a:spcBef>
        <a:buFont typeface="Arial" panose="020B0604020202020204" pitchFamily="34" charset="0"/>
        <a:buChar char="•"/>
        <a:defRPr sz="2665" kern="1200">
          <a:solidFill>
            <a:schemeClr val="tx1"/>
          </a:solidFill>
          <a:latin typeface="+mn-lt"/>
          <a:ea typeface="+mn-ea"/>
          <a:cs typeface="+mn-cs"/>
        </a:defRPr>
      </a:lvl7pPr>
      <a:lvl8pPr marL="5075949" indent="-338397" algn="l" defTabSz="1353586" rtl="0" eaLnBrk="1" latinLnBrk="0" hangingPunct="1">
        <a:lnSpc>
          <a:spcPct val="90000"/>
        </a:lnSpc>
        <a:spcBef>
          <a:spcPts val="740"/>
        </a:spcBef>
        <a:buFont typeface="Arial" panose="020B0604020202020204" pitchFamily="34" charset="0"/>
        <a:buChar char="•"/>
        <a:defRPr sz="2665" kern="1200">
          <a:solidFill>
            <a:schemeClr val="tx1"/>
          </a:solidFill>
          <a:latin typeface="+mn-lt"/>
          <a:ea typeface="+mn-ea"/>
          <a:cs typeface="+mn-cs"/>
        </a:defRPr>
      </a:lvl8pPr>
      <a:lvl9pPr marL="5752742" indent="-338397" algn="l" defTabSz="1353586" rtl="0" eaLnBrk="1" latinLnBrk="0" hangingPunct="1">
        <a:lnSpc>
          <a:spcPct val="90000"/>
        </a:lnSpc>
        <a:spcBef>
          <a:spcPts val="740"/>
        </a:spcBef>
        <a:buFont typeface="Arial" panose="020B0604020202020204" pitchFamily="34" charset="0"/>
        <a:buChar char="•"/>
        <a:defRPr sz="266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53586" rtl="0" eaLnBrk="1" latinLnBrk="0" hangingPunct="1">
        <a:defRPr sz="2665" kern="1200">
          <a:solidFill>
            <a:schemeClr val="tx1"/>
          </a:solidFill>
          <a:latin typeface="+mn-lt"/>
          <a:ea typeface="+mn-ea"/>
          <a:cs typeface="+mn-cs"/>
        </a:defRPr>
      </a:lvl1pPr>
      <a:lvl2pPr marL="676793" algn="l" defTabSz="1353586" rtl="0" eaLnBrk="1" latinLnBrk="0" hangingPunct="1">
        <a:defRPr sz="2665" kern="1200">
          <a:solidFill>
            <a:schemeClr val="tx1"/>
          </a:solidFill>
          <a:latin typeface="+mn-lt"/>
          <a:ea typeface="+mn-ea"/>
          <a:cs typeface="+mn-cs"/>
        </a:defRPr>
      </a:lvl2pPr>
      <a:lvl3pPr marL="1353586" algn="l" defTabSz="1353586" rtl="0" eaLnBrk="1" latinLnBrk="0" hangingPunct="1">
        <a:defRPr sz="2665" kern="1200">
          <a:solidFill>
            <a:schemeClr val="tx1"/>
          </a:solidFill>
          <a:latin typeface="+mn-lt"/>
          <a:ea typeface="+mn-ea"/>
          <a:cs typeface="+mn-cs"/>
        </a:defRPr>
      </a:lvl3pPr>
      <a:lvl4pPr marL="2030379" algn="l" defTabSz="1353586" rtl="0" eaLnBrk="1" latinLnBrk="0" hangingPunct="1">
        <a:defRPr sz="2665" kern="1200">
          <a:solidFill>
            <a:schemeClr val="tx1"/>
          </a:solidFill>
          <a:latin typeface="+mn-lt"/>
          <a:ea typeface="+mn-ea"/>
          <a:cs typeface="+mn-cs"/>
        </a:defRPr>
      </a:lvl4pPr>
      <a:lvl5pPr marL="2707173" algn="l" defTabSz="1353586" rtl="0" eaLnBrk="1" latinLnBrk="0" hangingPunct="1">
        <a:defRPr sz="2665" kern="1200">
          <a:solidFill>
            <a:schemeClr val="tx1"/>
          </a:solidFill>
          <a:latin typeface="+mn-lt"/>
          <a:ea typeface="+mn-ea"/>
          <a:cs typeface="+mn-cs"/>
        </a:defRPr>
      </a:lvl5pPr>
      <a:lvl6pPr marL="3383966" algn="l" defTabSz="1353586" rtl="0" eaLnBrk="1" latinLnBrk="0" hangingPunct="1">
        <a:defRPr sz="2665" kern="1200">
          <a:solidFill>
            <a:schemeClr val="tx1"/>
          </a:solidFill>
          <a:latin typeface="+mn-lt"/>
          <a:ea typeface="+mn-ea"/>
          <a:cs typeface="+mn-cs"/>
        </a:defRPr>
      </a:lvl6pPr>
      <a:lvl7pPr marL="4060759" algn="l" defTabSz="1353586" rtl="0" eaLnBrk="1" latinLnBrk="0" hangingPunct="1">
        <a:defRPr sz="2665" kern="1200">
          <a:solidFill>
            <a:schemeClr val="tx1"/>
          </a:solidFill>
          <a:latin typeface="+mn-lt"/>
          <a:ea typeface="+mn-ea"/>
          <a:cs typeface="+mn-cs"/>
        </a:defRPr>
      </a:lvl7pPr>
      <a:lvl8pPr marL="4737552" algn="l" defTabSz="1353586" rtl="0" eaLnBrk="1" latinLnBrk="0" hangingPunct="1">
        <a:defRPr sz="2665" kern="1200">
          <a:solidFill>
            <a:schemeClr val="tx1"/>
          </a:solidFill>
          <a:latin typeface="+mn-lt"/>
          <a:ea typeface="+mn-ea"/>
          <a:cs typeface="+mn-cs"/>
        </a:defRPr>
      </a:lvl8pPr>
      <a:lvl9pPr marL="5414345" algn="l" defTabSz="1353586" rtl="0" eaLnBrk="1" latinLnBrk="0" hangingPunct="1">
        <a:defRPr sz="266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表格 8">
            <a:extLst>
              <a:ext uri="{FF2B5EF4-FFF2-40B4-BE49-F238E27FC236}">
                <a16:creationId xmlns:a16="http://schemas.microsoft.com/office/drawing/2014/main" id="{CA6AB47B-0A57-470E-B220-C3061327D1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4849678"/>
              </p:ext>
            </p:extLst>
          </p:nvPr>
        </p:nvGraphicFramePr>
        <p:xfrm>
          <a:off x="1352550" y="2095500"/>
          <a:ext cx="11353801" cy="6972298"/>
        </p:xfrm>
        <a:graphic>
          <a:graphicData uri="http://schemas.openxmlformats.org/drawingml/2006/table">
            <a:tbl>
              <a:tblPr firstRow="1" firstCol="1" bandRow="1"/>
              <a:tblGrid>
                <a:gridCol w="1354004">
                  <a:extLst>
                    <a:ext uri="{9D8B030D-6E8A-4147-A177-3AD203B41FA5}">
                      <a16:colId xmlns:a16="http://schemas.microsoft.com/office/drawing/2014/main" val="2552437594"/>
                    </a:ext>
                  </a:extLst>
                </a:gridCol>
                <a:gridCol w="1329258">
                  <a:extLst>
                    <a:ext uri="{9D8B030D-6E8A-4147-A177-3AD203B41FA5}">
                      <a16:colId xmlns:a16="http://schemas.microsoft.com/office/drawing/2014/main" val="2349344500"/>
                    </a:ext>
                  </a:extLst>
                </a:gridCol>
                <a:gridCol w="1381679">
                  <a:extLst>
                    <a:ext uri="{9D8B030D-6E8A-4147-A177-3AD203B41FA5}">
                      <a16:colId xmlns:a16="http://schemas.microsoft.com/office/drawing/2014/main" val="347438382"/>
                    </a:ext>
                  </a:extLst>
                </a:gridCol>
                <a:gridCol w="2242726">
                  <a:extLst>
                    <a:ext uri="{9D8B030D-6E8A-4147-A177-3AD203B41FA5}">
                      <a16:colId xmlns:a16="http://schemas.microsoft.com/office/drawing/2014/main" val="2150810520"/>
                    </a:ext>
                  </a:extLst>
                </a:gridCol>
                <a:gridCol w="1802190">
                  <a:extLst>
                    <a:ext uri="{9D8B030D-6E8A-4147-A177-3AD203B41FA5}">
                      <a16:colId xmlns:a16="http://schemas.microsoft.com/office/drawing/2014/main" val="4207993528"/>
                    </a:ext>
                  </a:extLst>
                </a:gridCol>
                <a:gridCol w="1641996">
                  <a:extLst>
                    <a:ext uri="{9D8B030D-6E8A-4147-A177-3AD203B41FA5}">
                      <a16:colId xmlns:a16="http://schemas.microsoft.com/office/drawing/2014/main" val="1022663255"/>
                    </a:ext>
                  </a:extLst>
                </a:gridCol>
                <a:gridCol w="1601948">
                  <a:extLst>
                    <a:ext uri="{9D8B030D-6E8A-4147-A177-3AD203B41FA5}">
                      <a16:colId xmlns:a16="http://schemas.microsoft.com/office/drawing/2014/main" val="2520287198"/>
                    </a:ext>
                  </a:extLst>
                </a:gridCol>
              </a:tblGrid>
              <a:tr h="1063042"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800" b="1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ample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b="1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o. of Reads (×10</a:t>
                      </a:r>
                      <a:r>
                        <a:rPr lang="en-US" sz="1800" b="1" kern="100" baseline="300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sz="1800" b="1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b="1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Unique Mapped Reads (×10</a:t>
                      </a:r>
                      <a:r>
                        <a:rPr lang="en-US" sz="1800" b="1" kern="100" baseline="300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sz="1800" b="1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b="1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o. of Mapped Reads (×10</a:t>
                      </a:r>
                      <a:r>
                        <a:rPr lang="en-US" sz="1800" b="1" kern="100" baseline="300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sz="1800" b="1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b="1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apping Ratio (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b="1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ll Gene Number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9187279"/>
                  </a:ext>
                </a:extLst>
              </a:tr>
              <a:tr h="328292">
                <a:tc rowSpan="3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a 10-</a:t>
                      </a:r>
                      <a:r>
                        <a:rPr lang="en-US" altLang="zh-CN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a 10-S1-1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.72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5.78(66.59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6.57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8.62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9080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9461989"/>
                  </a:ext>
                </a:extLst>
              </a:tr>
              <a:tr h="3282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a 10-S1-2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.24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7.93(66.12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8.77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8.12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9138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6688829"/>
                  </a:ext>
                </a:extLst>
              </a:tr>
              <a:tr h="3282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a 10-S1-3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.28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7.51(66.65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8.35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8.68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9061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6174579"/>
                  </a:ext>
                </a:extLst>
              </a:tr>
              <a:tr h="328292">
                <a:tc rowSpan="3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a 10-S2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a 10-S2-1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.82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9.44(65.68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0.41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7.87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194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5184339"/>
                  </a:ext>
                </a:extLst>
              </a:tr>
              <a:tr h="3282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a 10-S2-2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5.87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6.19(64.78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7.43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7.01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389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5056192"/>
                  </a:ext>
                </a:extLst>
              </a:tr>
              <a:tr h="3282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a 10-S2-3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.51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8.53(65.59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9.49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7.80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099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9536033"/>
                  </a:ext>
                </a:extLst>
              </a:tr>
              <a:tr h="328292">
                <a:tc rowSpan="3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a 10-S3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a 10-S3-1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0.06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2.42(64.77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3.74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7.41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7156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2801258"/>
                  </a:ext>
                </a:extLst>
              </a:tr>
              <a:tr h="3282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a 10-S3-2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.68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6.88(64.48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7.99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7.17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806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8166909"/>
                  </a:ext>
                </a:extLst>
              </a:tr>
              <a:tr h="3282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a 10-S3-3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.98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9.21(64.96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0.42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7.64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848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9635391"/>
                  </a:ext>
                </a:extLst>
              </a:tr>
              <a:tr h="328292">
                <a:tc rowSpan="3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aisang-S1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aisang-1-1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.54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6.85(64.65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7.74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6.78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950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166056"/>
                  </a:ext>
                </a:extLst>
              </a:tr>
              <a:tr h="3282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aisang-1-2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4.58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2.55(65.22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3.29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7.36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924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9628004"/>
                  </a:ext>
                </a:extLst>
              </a:tr>
              <a:tr h="3282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aisang-1-3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.77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5.84(64.98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6.68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7.10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940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0237815"/>
                  </a:ext>
                </a:extLst>
              </a:tr>
              <a:tr h="328292">
                <a:tc rowSpan="3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aisang-S2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aisang-2-1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3.97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2.03(64.86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2.72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6.90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433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3724725"/>
                  </a:ext>
                </a:extLst>
              </a:tr>
              <a:tr h="3282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aisang-2-2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6.28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3.35(64.37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4.07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6.35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388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2543646"/>
                  </a:ext>
                </a:extLst>
              </a:tr>
              <a:tr h="3282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aisang-2-3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7.50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4.20(64.52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4.94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6.51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378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5048159"/>
                  </a:ext>
                </a:extLst>
              </a:tr>
              <a:tr h="328292">
                <a:tc rowSpan="3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aisang-S3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aisang-3-1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.97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7.45(65.41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8.25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7.31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7457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2348641"/>
                  </a:ext>
                </a:extLst>
              </a:tr>
              <a:tr h="3282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aisang-3-2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3.93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7.43(64.16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8.81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6.03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367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2248487"/>
                  </a:ext>
                </a:extLst>
              </a:tr>
              <a:tr h="3282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aisang-3-3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3.52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1.80(65.02%)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2.41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6.88%</a:t>
                      </a:r>
                      <a:endParaRPr lang="zh-CN" sz="1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7438</a:t>
                      </a:r>
                      <a:endParaRPr lang="zh-CN" sz="1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2301497"/>
                  </a:ext>
                </a:extLst>
              </a:tr>
            </a:tbl>
          </a:graphicData>
        </a:graphic>
      </p:graphicFrame>
      <p:sp>
        <p:nvSpPr>
          <p:cNvPr id="10" name="矩形 9">
            <a:extLst>
              <a:ext uri="{FF2B5EF4-FFF2-40B4-BE49-F238E27FC236}">
                <a16:creationId xmlns:a16="http://schemas.microsoft.com/office/drawing/2014/main" id="{0E328354-9D3B-436A-B8A8-5A33703DCE2D}"/>
              </a:ext>
            </a:extLst>
          </p:cNvPr>
          <p:cNvSpPr/>
          <p:nvPr/>
        </p:nvSpPr>
        <p:spPr>
          <a:xfrm>
            <a:off x="1558131" y="1084265"/>
            <a:ext cx="10420350" cy="8788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</a:rPr>
              <a:t>Table S1. Transcriptome sequence numbers of mapped reads from the  two mulberry genotypes at three developmental stages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224966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209</Words>
  <Application>Microsoft Office PowerPoint</Application>
  <PresentationFormat>自定义</PresentationFormat>
  <Paragraphs>12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ecurity Mail</dc:creator>
  <cp:lastModifiedBy>Security Mail</cp:lastModifiedBy>
  <cp:revision>6</cp:revision>
  <dcterms:created xsi:type="dcterms:W3CDTF">2019-11-21T08:09:37Z</dcterms:created>
  <dcterms:modified xsi:type="dcterms:W3CDTF">2020-01-07T00:56:52Z</dcterms:modified>
</cp:coreProperties>
</file>